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3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C6D20-E887-1CAF-D5F1-7740AA1F88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E83128-8749-05C1-3614-1DC9E8DEE7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ACEEB-33FE-41F5-5136-F9092B844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06A30-8A7B-1049-762A-68B30894E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927CC-318E-DBCA-1E8D-712AE2DB5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315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D5BA4-214A-FC65-33EF-DD88DAA5DD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6BAEF7-E55A-E9F6-0F79-31D2497B75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1461A-9ECE-718F-FA55-183CF4521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C73ED-20BD-9BE1-F00D-B8A54995D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FA959A-AEE6-69CD-20CE-EB48A022D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3767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21BBED-487D-D8CC-B1DA-A3D526A4A9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C27E2D-0CCC-A9A1-CA4A-07D9E564D5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6B96B-B230-037C-006C-AA77EA461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ADFED5-F4CB-D9C0-9AB2-D41E80AD0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B3434E-1AF2-ADB3-4781-BECA9057D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374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82104F-41D9-A733-9E71-681CDF995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5F458E-4379-81A2-3D60-7A458E97B8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481F2-0778-6311-629A-499FE7897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9526AD-22FC-320B-A35F-85A2B475D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EC626-BD48-B755-8281-1DF4031A2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7088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12047-8834-DD17-36FA-5873D996F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7F03D8-CB6E-2139-947D-4894DA2A5F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15442F-A4CE-E1AD-92BD-E8D8FFA97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D5692-ECE7-639E-2CA1-3C1C0960E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9EE5AB-D29F-75C8-FDC5-5100AE88F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960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28499-05D5-CAD0-3BFC-28B300872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4B29FA-716A-18D4-532B-B0C892CF5F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153AC4-2862-8262-8490-A42843AF3E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5A9FF8-9B7C-B3CD-BE44-55A1BC34E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263AAD-E277-55C3-5893-D2F21FB96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14F507-E342-33CA-00D0-BF34AE3D8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7700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057E4-8491-A8DE-BB81-378963348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C0F05E-ED38-09AE-DAEE-1EF3B51754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A5A0D7-6E26-714E-76EF-E9D78289E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D9058C-9B6A-6471-CA96-6E2FE3A1FC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D74232-47C0-BE42-7BF0-8D33EE0A89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B01076-B3A3-066A-F17D-B2A5EF00B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9323ED-1537-B617-2FB4-A7B7D827D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4A6550-2D36-976E-E6A6-7EBCFFFF2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72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8A09F-420E-40C9-23E3-2E5D7708A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944AE4-E7C5-28FC-AEAF-E19EED3C1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D4CD0F-66C1-AB5E-9FC5-4C829989D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E1BCAF-CCD3-A889-D9DC-D344293EB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0089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DFF931-60E7-B684-DDB8-99701BE4C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905D4A-42E6-5902-3D7D-C2C6130A6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F2DCE9-22C6-37B7-75EC-836E1359C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4013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CC0C8-28D1-4FD6-B5F5-A162B75601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FB1C25-6954-D246-C1C8-AD335AE733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068270-A392-0C09-A34C-F312F494E1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BF6B93-C91F-07D1-695F-DE307482B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CBBF9-327A-8892-746D-B81D3C0AB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F9CE43-A87A-8650-89F2-0A0D4223D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275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2228C-EE23-89B3-A359-30C265459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12209A-F1A2-B3AD-3979-DD0AF4AD59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C5EE83-1BB0-B1D8-1FEC-3B4E9687D2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0BC5E9-05B9-715C-11C9-4121FD131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2A0D54-2797-AD80-4B29-8E03D0984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98C71F-C762-6E51-1336-FF2F13ADB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603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F44CD-B3BE-88EE-9EBD-F2DCAC9FB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4034D1-BE20-6F17-D3F4-018F363AED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A6976-3D9B-5B1F-9360-F0C24FA93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FCDA6-1889-475B-AAE5-1BA43A16031E}" type="datetimeFigureOut">
              <a:rPr lang="en-GB" smtClean="0"/>
              <a:t>04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39035-8639-7406-F88B-4B2BB17AB9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0241B-23BE-C0BB-61A7-992D8842AD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46E4F-60A0-4B22-B639-54F4B4A6FB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4937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AD41BFC-F763-EA86-7BBF-AB1A7A5A06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474" y="1007046"/>
            <a:ext cx="2581635" cy="254353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31DF81C-527D-DA10-847F-1B3AE462D2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5811" y="1026098"/>
            <a:ext cx="2562583" cy="25054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CF7EA13-3AB0-8026-3CCE-4FABCFBCC5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11959" y="1007045"/>
            <a:ext cx="2621492" cy="254352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A34648E-75F3-813A-5081-2F1EF88347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00546" y="1024930"/>
            <a:ext cx="2621492" cy="257276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14E7931-FB72-4A00-8CAA-373B03C9704D}"/>
              </a:ext>
            </a:extLst>
          </p:cNvPr>
          <p:cNvSpPr txBox="1"/>
          <p:nvPr/>
        </p:nvSpPr>
        <p:spPr>
          <a:xfrm>
            <a:off x="133063" y="672846"/>
            <a:ext cx="540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906C2D3-39AD-F8A0-6ACB-B16EEB9810A6}"/>
              </a:ext>
            </a:extLst>
          </p:cNvPr>
          <p:cNvSpPr txBox="1"/>
          <p:nvPr/>
        </p:nvSpPr>
        <p:spPr>
          <a:xfrm>
            <a:off x="5685539" y="674279"/>
            <a:ext cx="540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DFD979E-A870-0575-23FF-36DD1CE24D53}"/>
              </a:ext>
            </a:extLst>
          </p:cNvPr>
          <p:cNvSpPr txBox="1"/>
          <p:nvPr/>
        </p:nvSpPr>
        <p:spPr>
          <a:xfrm>
            <a:off x="8657016" y="672846"/>
            <a:ext cx="540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264FB90-7179-60B5-0C1B-73B73A2F10A4}"/>
              </a:ext>
            </a:extLst>
          </p:cNvPr>
          <p:cNvSpPr txBox="1"/>
          <p:nvPr/>
        </p:nvSpPr>
        <p:spPr>
          <a:xfrm>
            <a:off x="2928666" y="672846"/>
            <a:ext cx="540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7111D4B-FF28-CA96-2098-1A2992ED8E39}"/>
              </a:ext>
            </a:extLst>
          </p:cNvPr>
          <p:cNvSpPr txBox="1"/>
          <p:nvPr/>
        </p:nvSpPr>
        <p:spPr>
          <a:xfrm>
            <a:off x="460075" y="4094672"/>
            <a:ext cx="111970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 X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epresentative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low cytometry dot plots for enumeration of CD34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KD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cells in peripheral blood. A- Gating of CD45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cells, B- exclusion of non-viable (7AAD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cells, C- Gating of CD34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progenitor cells, D- Subsequent analysis of CD34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KD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cells</a:t>
            </a:r>
            <a:endParaRPr lang="en-GB" sz="18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456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Ross</dc:creator>
  <cp:lastModifiedBy>Mark Ross</cp:lastModifiedBy>
  <cp:revision>2</cp:revision>
  <dcterms:created xsi:type="dcterms:W3CDTF">2022-07-04T09:26:31Z</dcterms:created>
  <dcterms:modified xsi:type="dcterms:W3CDTF">2022-07-04T09:29:39Z</dcterms:modified>
</cp:coreProperties>
</file>